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9" r:id="rId2"/>
  </p:sldIdLst>
  <p:sldSz cx="6119813" cy="7920038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95" userDrawn="1">
          <p15:clr>
            <a:srgbClr val="A4A3A4"/>
          </p15:clr>
        </p15:guide>
        <p15:guide id="2" pos="192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ercury evodevo" initials="me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065" autoAdjust="0"/>
  </p:normalViewPr>
  <p:slideViewPr>
    <p:cSldViewPr snapToGrid="0">
      <p:cViewPr varScale="1">
        <p:scale>
          <a:sx n="84" d="100"/>
          <a:sy n="84" d="100"/>
        </p:scale>
        <p:origin x="2151" y="30"/>
      </p:cViewPr>
      <p:guideLst>
        <p:guide orient="horz" pos="2495"/>
        <p:guide pos="192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safumi Funakoshi" userId="7312ffba83ed26af" providerId="LiveId" clId="{DF9F83E5-EE48-4060-B43F-264DB52CD9AC}"/>
    <pc:docChg chg="modSld">
      <pc:chgData name="Masafumi Funakoshi" userId="7312ffba83ed26af" providerId="LiveId" clId="{DF9F83E5-EE48-4060-B43F-264DB52CD9AC}" dt="2017-09-20T11:07:15.985" v="15"/>
      <pc:docMkLst>
        <pc:docMk/>
      </pc:docMkLst>
      <pc:sldChg chg="modSp">
        <pc:chgData name="Masafumi Funakoshi" userId="7312ffba83ed26af" providerId="LiveId" clId="{DF9F83E5-EE48-4060-B43F-264DB52CD9AC}" dt="2017-09-20T11:07:15.985" v="15"/>
        <pc:sldMkLst>
          <pc:docMk/>
          <pc:sldMk cId="2201343144" sldId="259"/>
        </pc:sldMkLst>
        <pc:spChg chg="mod">
          <ac:chgData name="Masafumi Funakoshi" userId="7312ffba83ed26af" providerId="LiveId" clId="{DF9F83E5-EE48-4060-B43F-264DB52CD9AC}" dt="2017-09-20T11:07:15.985" v="15"/>
          <ac:spMkLst>
            <pc:docMk/>
            <pc:sldMk cId="2201343144" sldId="259"/>
            <ac:spMk id="61" creationId="{00000000-0000-0000-0000-000000000000}"/>
          </ac:spMkLst>
        </pc:spChg>
        <pc:spChg chg="mod">
          <ac:chgData name="Masafumi Funakoshi" userId="7312ffba83ed26af" providerId="LiveId" clId="{DF9F83E5-EE48-4060-B43F-264DB52CD9AC}" dt="2017-09-20T11:07:15.985" v="15"/>
          <ac:spMkLst>
            <pc:docMk/>
            <pc:sldMk cId="2201343144" sldId="259"/>
            <ac:spMk id="145" creationId="{00000000-0000-0000-0000-000000000000}"/>
          </ac:spMkLst>
        </pc:spChg>
        <pc:spChg chg="mod">
          <ac:chgData name="Masafumi Funakoshi" userId="7312ffba83ed26af" providerId="LiveId" clId="{DF9F83E5-EE48-4060-B43F-264DB52CD9AC}" dt="2017-09-20T11:07:15.985" v="15"/>
          <ac:spMkLst>
            <pc:docMk/>
            <pc:sldMk cId="2201343144" sldId="259"/>
            <ac:spMk id="146" creationId="{00000000-0000-0000-0000-000000000000}"/>
          </ac:spMkLst>
        </pc:spChg>
        <pc:grpChg chg="mod">
          <ac:chgData name="Masafumi Funakoshi" userId="7312ffba83ed26af" providerId="LiveId" clId="{DF9F83E5-EE48-4060-B43F-264DB52CD9AC}" dt="2017-09-20T11:07:15.985" v="15"/>
          <ac:grpSpMkLst>
            <pc:docMk/>
            <pc:sldMk cId="2201343144" sldId="259"/>
            <ac:grpSpMk id="66" creationId="{00000000-0000-0000-0000-000000000000}"/>
          </ac:grpSpMkLst>
        </pc:grpChg>
        <pc:grpChg chg="mod">
          <ac:chgData name="Masafumi Funakoshi" userId="7312ffba83ed26af" providerId="LiveId" clId="{DF9F83E5-EE48-4060-B43F-264DB52CD9AC}" dt="2017-09-20T11:07:15.985" v="15"/>
          <ac:grpSpMkLst>
            <pc:docMk/>
            <pc:sldMk cId="2201343144" sldId="259"/>
            <ac:grpSpMk id="148" creationId="{00000000-0000-0000-0000-000000000000}"/>
          </ac:grpSpMkLst>
        </pc:grpChg>
        <pc:graphicFrameChg chg="mod">
          <ac:chgData name="Masafumi Funakoshi" userId="7312ffba83ed26af" providerId="LiveId" clId="{DF9F83E5-EE48-4060-B43F-264DB52CD9AC}" dt="2017-09-20T11:07:15.985" v="15"/>
          <ac:graphicFrameMkLst>
            <pc:docMk/>
            <pc:sldMk cId="2201343144" sldId="259"/>
            <ac:graphicFrameMk id="62" creationId="{00000000-0000-0000-0000-000000000000}"/>
          </ac:graphicFrameMkLst>
        </pc:graphicFrameChg>
        <pc:graphicFrameChg chg="mod">
          <ac:chgData name="Masafumi Funakoshi" userId="7312ffba83ed26af" providerId="LiveId" clId="{DF9F83E5-EE48-4060-B43F-264DB52CD9AC}" dt="2017-09-20T11:07:15.985" v="15"/>
          <ac:graphicFrameMkLst>
            <pc:docMk/>
            <pc:sldMk cId="2201343144" sldId="259"/>
            <ac:graphicFrameMk id="63" creationId="{00000000-0000-0000-0000-000000000000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26124;&#21490;\OneDrive\CiAPE2%20&#35542;&#25991;&#20316;&#25104;&#29992;&#36039;&#26009;\&#36861;&#21152;&#23455;&#39443;\&#26657;&#27491;&#27231;&#33021;&#12289;&#23450;&#37327;&#32080;&#26524;%2020170906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26124;&#21490;\OneDrive\CiAPE2%20&#35542;&#25991;&#20316;&#25104;&#29992;&#36039;&#26009;\&#36861;&#21152;&#23455;&#39443;\&#26657;&#27491;&#27231;&#33021;&#12289;&#23450;&#37327;&#32080;&#26524;%2020170906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I$8</c:f>
              <c:strCache>
                <c:ptCount val="1"/>
                <c:pt idx="0">
                  <c:v>CiP0 Match</c:v>
                </c:pt>
              </c:strCache>
            </c:strRef>
          </c:tx>
          <c:spPr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Sheet2!$J$7:$M$7</c:f>
              <c:strCache>
                <c:ptCount val="4"/>
                <c:pt idx="0">
                  <c:v>0 pmol</c:v>
                </c:pt>
                <c:pt idx="1">
                  <c:v>0.01 pmol</c:v>
                </c:pt>
                <c:pt idx="2">
                  <c:v>0.1 pmol</c:v>
                </c:pt>
                <c:pt idx="3">
                  <c:v>1 pmol</c:v>
                </c:pt>
              </c:strCache>
            </c:strRef>
          </c:cat>
          <c:val>
            <c:numRef>
              <c:f>Sheet2!$J$8:$M$8</c:f>
              <c:numCache>
                <c:formatCode>General</c:formatCode>
                <c:ptCount val="4"/>
                <c:pt idx="0">
                  <c:v>1.2722645769057535</c:v>
                </c:pt>
                <c:pt idx="1">
                  <c:v>1.5114209602320732</c:v>
                </c:pt>
                <c:pt idx="2">
                  <c:v>5.1957726692400268</c:v>
                </c:pt>
                <c:pt idx="3">
                  <c:v>62.6201680779875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412-4256-BE70-EA36E6F1A2DF}"/>
            </c:ext>
          </c:extLst>
        </c:ser>
        <c:ser>
          <c:idx val="1"/>
          <c:order val="1"/>
          <c:tx>
            <c:strRef>
              <c:f>Sheet2!$I$9</c:f>
              <c:strCache>
                <c:ptCount val="1"/>
                <c:pt idx="0">
                  <c:v>CiP0 Mismatch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2!$J$7:$M$7</c:f>
              <c:strCache>
                <c:ptCount val="4"/>
                <c:pt idx="0">
                  <c:v>0 pmol</c:v>
                </c:pt>
                <c:pt idx="1">
                  <c:v>0.01 pmol</c:v>
                </c:pt>
                <c:pt idx="2">
                  <c:v>0.1 pmol</c:v>
                </c:pt>
                <c:pt idx="3">
                  <c:v>1 pmol</c:v>
                </c:pt>
              </c:strCache>
            </c:strRef>
          </c:cat>
          <c:val>
            <c:numRef>
              <c:f>Sheet2!$J$9:$M$9</c:f>
              <c:numCache>
                <c:formatCode>General</c:formatCode>
                <c:ptCount val="4"/>
                <c:pt idx="0">
                  <c:v>2.3125297629026509</c:v>
                </c:pt>
                <c:pt idx="1">
                  <c:v>2.0448490386663893</c:v>
                </c:pt>
                <c:pt idx="2">
                  <c:v>4.7523248316142475</c:v>
                </c:pt>
                <c:pt idx="3">
                  <c:v>29.6843280398440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412-4256-BE70-EA36E6F1A2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5557712"/>
        <c:axId val="525547128"/>
      </c:barChart>
      <c:catAx>
        <c:axId val="525557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ja-JP"/>
          </a:p>
        </c:txPr>
        <c:crossAx val="525547128"/>
        <c:crosses val="autoZero"/>
        <c:auto val="1"/>
        <c:lblAlgn val="ctr"/>
        <c:lblOffset val="100"/>
        <c:noMultiLvlLbl val="0"/>
      </c:catAx>
      <c:valAx>
        <c:axId val="525547128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ja-JP"/>
          </a:p>
        </c:txPr>
        <c:crossAx val="5255577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aseline="0">
          <a:solidFill>
            <a:sysClr val="windowText" lastClr="000000"/>
          </a:solidFill>
          <a:latin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I$8</c:f>
              <c:strCache>
                <c:ptCount val="1"/>
                <c:pt idx="0">
                  <c:v>CiAPEX2 Match</c:v>
                </c:pt>
              </c:strCache>
            </c:strRef>
          </c:tx>
          <c:spPr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Sheet1!$J$7:$M$7</c:f>
              <c:strCache>
                <c:ptCount val="4"/>
                <c:pt idx="0">
                  <c:v>0 pmol</c:v>
                </c:pt>
                <c:pt idx="1">
                  <c:v>0.01 pmol</c:v>
                </c:pt>
                <c:pt idx="2">
                  <c:v>0.1 pmol</c:v>
                </c:pt>
                <c:pt idx="3">
                  <c:v>1 pmol</c:v>
                </c:pt>
              </c:strCache>
            </c:strRef>
          </c:cat>
          <c:val>
            <c:numRef>
              <c:f>Sheet1!$J$8:$M$8</c:f>
              <c:numCache>
                <c:formatCode>General</c:formatCode>
                <c:ptCount val="4"/>
                <c:pt idx="0">
                  <c:v>4.1274676267246075</c:v>
                </c:pt>
                <c:pt idx="1">
                  <c:v>6.6457434889866329</c:v>
                </c:pt>
                <c:pt idx="2">
                  <c:v>34.242498903100177</c:v>
                </c:pt>
                <c:pt idx="3">
                  <c:v>77.2191407695924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8D8-4047-8635-2F823A36A54C}"/>
            </c:ext>
          </c:extLst>
        </c:ser>
        <c:ser>
          <c:idx val="1"/>
          <c:order val="1"/>
          <c:tx>
            <c:strRef>
              <c:f>Sheet1!$I$9</c:f>
              <c:strCache>
                <c:ptCount val="1"/>
                <c:pt idx="0">
                  <c:v>CiAPEX2 Mismatch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1!$J$7:$M$7</c:f>
              <c:strCache>
                <c:ptCount val="4"/>
                <c:pt idx="0">
                  <c:v>0 pmol</c:v>
                </c:pt>
                <c:pt idx="1">
                  <c:v>0.01 pmol</c:v>
                </c:pt>
                <c:pt idx="2">
                  <c:v>0.1 pmol</c:v>
                </c:pt>
                <c:pt idx="3">
                  <c:v>1 pmol</c:v>
                </c:pt>
              </c:strCache>
            </c:strRef>
          </c:cat>
          <c:val>
            <c:numRef>
              <c:f>Sheet1!$J$9:$M$9</c:f>
              <c:numCache>
                <c:formatCode>General</c:formatCode>
                <c:ptCount val="4"/>
                <c:pt idx="0">
                  <c:v>2.3883911821691131</c:v>
                </c:pt>
                <c:pt idx="1">
                  <c:v>1.9847620153612939</c:v>
                </c:pt>
                <c:pt idx="2">
                  <c:v>7.2287456322601527</c:v>
                </c:pt>
                <c:pt idx="3">
                  <c:v>33.5775056846540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8D8-4047-8635-2F823A36A5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5556144"/>
        <c:axId val="525551048"/>
      </c:barChart>
      <c:catAx>
        <c:axId val="5255561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25551048"/>
        <c:crosses val="autoZero"/>
        <c:auto val="1"/>
        <c:lblAlgn val="ctr"/>
        <c:lblOffset val="100"/>
        <c:noMultiLvlLbl val="0"/>
      </c:catAx>
      <c:valAx>
        <c:axId val="52555104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255561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 b="0" baseline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6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E73336-FAC9-4A2C-88E7-792E6988F1EB}" type="datetimeFigureOut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05025" y="1241425"/>
            <a:ext cx="25876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7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3" y="9428587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6" y="9428587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DA476A-3C25-43B9-8FE8-BCD577C0B43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52571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296173"/>
            <a:ext cx="5201841" cy="2757347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159854"/>
            <a:ext cx="4589860" cy="1912175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0B2B7-4490-4608-AA8F-A7840A08855B}" type="datetime1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75D45-7618-4FBB-87E7-C00081EC6C9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38005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DACB40-4953-4265-9569-961E1624894F}" type="datetime1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75D45-7618-4FBB-87E7-C00081EC6C9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8778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21669"/>
            <a:ext cx="1319585" cy="671186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21669"/>
            <a:ext cx="3882256" cy="671186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6013E-CEC7-4E3B-8006-872D2E50388C}" type="datetime1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75D45-7618-4FBB-87E7-C00081EC6C9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4413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67A60-AB92-4FFC-8E46-38DB8F928EAC}" type="datetime1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75D45-7618-4FBB-87E7-C00081EC6C9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72480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1974512"/>
            <a:ext cx="5278339" cy="3294515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300194"/>
            <a:ext cx="5278339" cy="1732508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170B3-F58C-4DCE-A750-C7789A58373A}" type="datetime1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75D45-7618-4FBB-87E7-C00081EC6C9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65977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108344"/>
            <a:ext cx="2600921" cy="502519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108344"/>
            <a:ext cx="2600921" cy="502519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C9CD0-9DFC-4E84-9CEA-2CA25FC7BCD2}" type="datetime1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75D45-7618-4FBB-87E7-C00081EC6C9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06127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21671"/>
            <a:ext cx="5278339" cy="1530841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941510"/>
            <a:ext cx="2588967" cy="95150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893014"/>
            <a:ext cx="2588967" cy="42551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941510"/>
            <a:ext cx="2601718" cy="95150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893014"/>
            <a:ext cx="2601718" cy="42551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31B04-387E-40EE-B163-99B78A33AA85}" type="datetime1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75D45-7618-4FBB-87E7-C00081EC6C9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40332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E9F35-3E55-4C55-A9B0-5BA248DD0EAE}" type="datetime1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75D45-7618-4FBB-87E7-C00081EC6C9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58231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8D5462-AA59-48C1-A6A2-48217126207E}" type="datetime1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75D45-7618-4FBB-87E7-C00081EC6C9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71629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28002"/>
            <a:ext cx="1973799" cy="1848009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40341"/>
            <a:ext cx="3098155" cy="5628360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376011"/>
            <a:ext cx="1973799" cy="440185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90FD8-0641-43C5-A5FE-E2B76F8F1E9E}" type="datetime1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75D45-7618-4FBB-87E7-C00081EC6C9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48396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28002"/>
            <a:ext cx="1973799" cy="1848009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40341"/>
            <a:ext cx="3098155" cy="5628360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376011"/>
            <a:ext cx="1973799" cy="440185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9FC657-474C-40A7-B534-427D226AFEDD}" type="datetime1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75D45-7618-4FBB-87E7-C00081EC6C9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8918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21671"/>
            <a:ext cx="5278339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108344"/>
            <a:ext cx="5278339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340703"/>
            <a:ext cx="137695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203017-F92D-493A-A01F-8A29A84A1814}" type="datetime1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340703"/>
            <a:ext cx="2065437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340703"/>
            <a:ext cx="137695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075D45-7618-4FBB-87E7-C00081EC6C9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91861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kumimoji="1"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kumimoji="1"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コンテンツ プレースホルダー 2"/>
          <p:cNvSpPr txBox="1">
            <a:spLocks/>
          </p:cNvSpPr>
          <p:nvPr/>
        </p:nvSpPr>
        <p:spPr>
          <a:xfrm>
            <a:off x="5439721" y="7572345"/>
            <a:ext cx="1295176" cy="456928"/>
          </a:xfrm>
          <a:prstGeom prst="rect">
            <a:avLst/>
          </a:prstGeom>
        </p:spPr>
        <p:txBody>
          <a:bodyPr vert="horz" lIns="105601" tIns="52800" rIns="105601" bIns="5280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2S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2" name="グラフ 6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69869735"/>
              </p:ext>
            </p:extLst>
          </p:nvPr>
        </p:nvGraphicFramePr>
        <p:xfrm>
          <a:off x="2910812" y="4624171"/>
          <a:ext cx="3174506" cy="19047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3" name="グラフ 6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72150361"/>
              </p:ext>
            </p:extLst>
          </p:nvPr>
        </p:nvGraphicFramePr>
        <p:xfrm>
          <a:off x="19889" y="4624171"/>
          <a:ext cx="3174506" cy="19047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148" name="グループ化 147"/>
          <p:cNvGrpSpPr/>
          <p:nvPr/>
        </p:nvGrpSpPr>
        <p:grpSpPr>
          <a:xfrm>
            <a:off x="-188451" y="1463097"/>
            <a:ext cx="7292590" cy="2878756"/>
            <a:chOff x="-188451" y="1034625"/>
            <a:chExt cx="7292590" cy="2878756"/>
          </a:xfrm>
        </p:grpSpPr>
        <p:sp>
          <p:nvSpPr>
            <p:cNvPr id="143" name="正方形/長方形 142"/>
            <p:cNvSpPr/>
            <p:nvPr/>
          </p:nvSpPr>
          <p:spPr>
            <a:xfrm>
              <a:off x="-65928" y="1034625"/>
              <a:ext cx="759449" cy="63820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endParaRPr lang="ja-JP" alt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42" name="グループ化 141"/>
            <p:cNvGrpSpPr/>
            <p:nvPr/>
          </p:nvGrpSpPr>
          <p:grpSpPr>
            <a:xfrm>
              <a:off x="-188451" y="1286367"/>
              <a:ext cx="7292590" cy="2627014"/>
              <a:chOff x="-304563" y="1591164"/>
              <a:chExt cx="7292590" cy="2627014"/>
            </a:xfrm>
          </p:grpSpPr>
          <p:grpSp>
            <p:nvGrpSpPr>
              <p:cNvPr id="141" name="グループ化 140"/>
              <p:cNvGrpSpPr/>
              <p:nvPr/>
            </p:nvGrpSpPr>
            <p:grpSpPr>
              <a:xfrm>
                <a:off x="4908089" y="1591164"/>
                <a:ext cx="2079938" cy="1241883"/>
                <a:chOff x="4908089" y="1591164"/>
                <a:chExt cx="2079938" cy="1241883"/>
              </a:xfrm>
            </p:grpSpPr>
            <p:sp>
              <p:nvSpPr>
                <p:cNvPr id="96" name="正方形/長方形 95"/>
                <p:cNvSpPr/>
                <p:nvPr/>
              </p:nvSpPr>
              <p:spPr>
                <a:xfrm>
                  <a:off x="4908089" y="1591164"/>
                  <a:ext cx="2079938" cy="56667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Meiryo UI" panose="020B0604030504040204" pitchFamily="50" charset="-128"/>
                      <a:cs typeface="Times New Roman" panose="02020603050405020304" pitchFamily="18" charset="0"/>
                    </a:rPr>
                    <a:t>Protein name</a:t>
                  </a:r>
                  <a:endParaRPr lang="ja-JP" altLang="en-US" sz="10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Meiryo UI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7" name="正方形/長方形 96"/>
                <p:cNvSpPr/>
                <p:nvPr/>
              </p:nvSpPr>
              <p:spPr>
                <a:xfrm>
                  <a:off x="4908089" y="1961583"/>
                  <a:ext cx="2079938" cy="56667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Meiryo UI" panose="020B0604030504040204" pitchFamily="50" charset="-128"/>
                      <a:cs typeface="Times New Roman" panose="02020603050405020304" pitchFamily="18" charset="0"/>
                    </a:rPr>
                    <a:t>Substrate name</a:t>
                  </a:r>
                  <a:endParaRPr lang="ja-JP" altLang="en-US" sz="10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Meiryo UI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8" name="正方形/長方形 97"/>
                <p:cNvSpPr/>
                <p:nvPr/>
              </p:nvSpPr>
              <p:spPr>
                <a:xfrm>
                  <a:off x="4908089" y="2266377"/>
                  <a:ext cx="2079938" cy="56667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Meiryo UI" panose="020B0604030504040204" pitchFamily="50" charset="-128"/>
                      <a:cs typeface="Times New Roman" panose="02020603050405020304" pitchFamily="18" charset="0"/>
                    </a:rPr>
                    <a:t>Concentration</a:t>
                  </a:r>
                  <a:endParaRPr lang="ja-JP" altLang="en-US" sz="10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Meiryo UI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64" name="正方形/長方形 63"/>
              <p:cNvSpPr/>
              <p:nvPr/>
            </p:nvSpPr>
            <p:spPr>
              <a:xfrm>
                <a:off x="245752" y="1591164"/>
                <a:ext cx="2079938" cy="56667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10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Meiryo UI" panose="020B0604030504040204" pitchFamily="50" charset="-128"/>
                    <a:cs typeface="Times New Roman" panose="02020603050405020304" pitchFamily="18" charset="0"/>
                  </a:rPr>
                  <a:t>His-CiAPEX2</a:t>
                </a:r>
                <a:endParaRPr kumimoji="1" lang="ja-JP" altLang="en-US" sz="1000" dirty="0">
                  <a:solidFill>
                    <a:schemeClr val="tx1"/>
                  </a:solidFill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正方形/長方形 74"/>
              <p:cNvSpPr/>
              <p:nvPr/>
            </p:nvSpPr>
            <p:spPr>
              <a:xfrm>
                <a:off x="936659" y="1961583"/>
                <a:ext cx="2079938" cy="56667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10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Meiryo UI" panose="020B0604030504040204" pitchFamily="50" charset="-128"/>
                    <a:cs typeface="Times New Roman" panose="02020603050405020304" pitchFamily="18" charset="0"/>
                  </a:rPr>
                  <a:t>Mismatched DNA</a:t>
                </a:r>
                <a:endParaRPr lang="ja-JP" altLang="en-US" sz="1000" dirty="0">
                  <a:solidFill>
                    <a:schemeClr val="tx1"/>
                  </a:solidFill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正方形/長方形 75"/>
              <p:cNvSpPr/>
              <p:nvPr/>
            </p:nvSpPr>
            <p:spPr>
              <a:xfrm>
                <a:off x="-304563" y="1961583"/>
                <a:ext cx="2079938" cy="56667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10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Meiryo UI" panose="020B0604030504040204" pitchFamily="50" charset="-128"/>
                    <a:cs typeface="Times New Roman" panose="02020603050405020304" pitchFamily="18" charset="0"/>
                  </a:rPr>
                  <a:t>Matched DNA</a:t>
                </a:r>
                <a:endParaRPr lang="ja-JP" altLang="en-US" sz="1000" dirty="0">
                  <a:solidFill>
                    <a:schemeClr val="tx1"/>
                  </a:solidFill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5" name="直線コネクタ 64"/>
              <p:cNvCxnSpPr/>
              <p:nvPr/>
            </p:nvCxnSpPr>
            <p:spPr>
              <a:xfrm>
                <a:off x="207873" y="2350086"/>
                <a:ext cx="1009493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7" name="AutoShape 5"/>
              <p:cNvSpPr>
                <a:spLocks noChangeArrowheads="1"/>
              </p:cNvSpPr>
              <p:nvPr/>
            </p:nvSpPr>
            <p:spPr bwMode="auto">
              <a:xfrm flipH="1">
                <a:off x="522546" y="2440781"/>
                <a:ext cx="687081" cy="186582"/>
              </a:xfrm>
              <a:prstGeom prst="rtTriangle">
                <a:avLst/>
              </a:prstGeom>
              <a:solidFill>
                <a:schemeClr val="tx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ja-JP" altLang="en-US" sz="100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" name="正方形/長方形 67"/>
              <p:cNvSpPr/>
              <p:nvPr/>
            </p:nvSpPr>
            <p:spPr>
              <a:xfrm>
                <a:off x="75718" y="2422371"/>
                <a:ext cx="511406" cy="35013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kumimoji="1" lang="en-US" altLang="ja-JP" sz="10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Meiryo UI" panose="020B0604030504040204" pitchFamily="50" charset="-128"/>
                    <a:cs typeface="Times New Roman" panose="02020603050405020304" pitchFamily="18" charset="0"/>
                  </a:rPr>
                  <a:t>-</a:t>
                </a:r>
                <a:endParaRPr kumimoji="1" lang="ja-JP" altLang="en-US" sz="10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" name="AutoShape 5"/>
              <p:cNvSpPr>
                <a:spLocks noChangeArrowheads="1"/>
              </p:cNvSpPr>
              <p:nvPr/>
            </p:nvSpPr>
            <p:spPr bwMode="auto">
              <a:xfrm flipH="1">
                <a:off x="1697772" y="2440781"/>
                <a:ext cx="687081" cy="186582"/>
              </a:xfrm>
              <a:prstGeom prst="rtTriangle">
                <a:avLst/>
              </a:prstGeom>
              <a:solidFill>
                <a:schemeClr val="tx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ja-JP" altLang="en-US" sz="100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" name="正方形/長方形 69"/>
              <p:cNvSpPr/>
              <p:nvPr/>
            </p:nvSpPr>
            <p:spPr>
              <a:xfrm>
                <a:off x="1289494" y="2422371"/>
                <a:ext cx="511406" cy="35013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kumimoji="1" lang="en-US" altLang="ja-JP" sz="10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Meiryo UI" panose="020B0604030504040204" pitchFamily="50" charset="-128"/>
                    <a:cs typeface="Times New Roman" panose="02020603050405020304" pitchFamily="18" charset="0"/>
                  </a:rPr>
                  <a:t>-</a:t>
                </a:r>
                <a:endParaRPr kumimoji="1" lang="ja-JP" altLang="en-US" sz="10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71" name="直線コネクタ 70"/>
              <p:cNvCxnSpPr/>
              <p:nvPr/>
            </p:nvCxnSpPr>
            <p:spPr>
              <a:xfrm>
                <a:off x="207873" y="2022236"/>
                <a:ext cx="2273502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直線コネクタ 123"/>
              <p:cNvCxnSpPr/>
              <p:nvPr/>
            </p:nvCxnSpPr>
            <p:spPr>
              <a:xfrm>
                <a:off x="1471882" y="2350086"/>
                <a:ext cx="1009493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正方形/長方形 86"/>
              <p:cNvSpPr/>
              <p:nvPr/>
            </p:nvSpPr>
            <p:spPr>
              <a:xfrm>
                <a:off x="2739826" y="1591164"/>
                <a:ext cx="2079938" cy="56667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kumimoji="1" lang="en-US" altLang="ja-JP" sz="10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Meiryo UI" panose="020B0604030504040204" pitchFamily="50" charset="-128"/>
                    <a:cs typeface="Times New Roman" panose="02020603050405020304" pitchFamily="18" charset="0"/>
                  </a:rPr>
                  <a:t>Tag-free CiP0</a:t>
                </a:r>
                <a:endParaRPr kumimoji="1" lang="ja-JP" altLang="en-US" sz="1000" dirty="0">
                  <a:solidFill>
                    <a:schemeClr val="tx1"/>
                  </a:solidFill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88" name="直線コネクタ 87"/>
              <p:cNvCxnSpPr/>
              <p:nvPr/>
            </p:nvCxnSpPr>
            <p:spPr>
              <a:xfrm>
                <a:off x="2699226" y="2350086"/>
                <a:ext cx="1000424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直線コネクタ 88"/>
              <p:cNvCxnSpPr/>
              <p:nvPr/>
            </p:nvCxnSpPr>
            <p:spPr>
              <a:xfrm>
                <a:off x="2699226" y="2022236"/>
                <a:ext cx="2173021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9" name="正方形/長方形 98"/>
              <p:cNvSpPr/>
              <p:nvPr/>
            </p:nvSpPr>
            <p:spPr>
              <a:xfrm>
                <a:off x="3331926" y="1961583"/>
                <a:ext cx="2079938" cy="56667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10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Meiryo UI" panose="020B0604030504040204" pitchFamily="50" charset="-128"/>
                    <a:cs typeface="Times New Roman" panose="02020603050405020304" pitchFamily="18" charset="0"/>
                  </a:rPr>
                  <a:t>Mismatched DNA</a:t>
                </a:r>
                <a:endParaRPr lang="ja-JP" altLang="en-US" sz="1000" dirty="0">
                  <a:solidFill>
                    <a:schemeClr val="tx1"/>
                  </a:solidFill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" name="正方形/長方形 99"/>
              <p:cNvSpPr/>
              <p:nvPr/>
            </p:nvSpPr>
            <p:spPr>
              <a:xfrm>
                <a:off x="2187769" y="1961583"/>
                <a:ext cx="2079938" cy="56667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10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Meiryo UI" panose="020B0604030504040204" pitchFamily="50" charset="-128"/>
                    <a:cs typeface="Times New Roman" panose="02020603050405020304" pitchFamily="18" charset="0"/>
                  </a:rPr>
                  <a:t>Matched DNA</a:t>
                </a:r>
                <a:endParaRPr lang="ja-JP" altLang="en-US" sz="1000" dirty="0">
                  <a:solidFill>
                    <a:schemeClr val="tx1"/>
                  </a:solidFill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91" name="AutoShape 5"/>
              <p:cNvSpPr>
                <a:spLocks noChangeArrowheads="1"/>
              </p:cNvSpPr>
              <p:nvPr/>
            </p:nvSpPr>
            <p:spPr bwMode="auto">
              <a:xfrm flipH="1">
                <a:off x="3012569" y="2440781"/>
                <a:ext cx="687081" cy="186582"/>
              </a:xfrm>
              <a:prstGeom prst="rtTriangle">
                <a:avLst/>
              </a:prstGeom>
              <a:solidFill>
                <a:schemeClr val="tx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ja-JP" altLang="en-US" sz="100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" name="正方形/長方形 91"/>
              <p:cNvSpPr/>
              <p:nvPr/>
            </p:nvSpPr>
            <p:spPr>
              <a:xfrm>
                <a:off x="2581783" y="2422371"/>
                <a:ext cx="511406" cy="35013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kumimoji="1" lang="en-US" altLang="ja-JP" sz="10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Meiryo UI" panose="020B0604030504040204" pitchFamily="50" charset="-128"/>
                    <a:cs typeface="Times New Roman" panose="02020603050405020304" pitchFamily="18" charset="0"/>
                  </a:rPr>
                  <a:t>-</a:t>
                </a:r>
                <a:endParaRPr kumimoji="1" lang="ja-JP" altLang="en-US" sz="10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94" name="AutoShape 5"/>
              <p:cNvSpPr>
                <a:spLocks noChangeArrowheads="1"/>
              </p:cNvSpPr>
              <p:nvPr/>
            </p:nvSpPr>
            <p:spPr bwMode="auto">
              <a:xfrm flipH="1">
                <a:off x="4166965" y="2440781"/>
                <a:ext cx="687081" cy="186582"/>
              </a:xfrm>
              <a:prstGeom prst="rtTriangle">
                <a:avLst/>
              </a:prstGeom>
              <a:solidFill>
                <a:schemeClr val="tx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ja-JP" altLang="en-US" sz="100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95" name="正方形/長方形 94"/>
              <p:cNvSpPr/>
              <p:nvPr/>
            </p:nvSpPr>
            <p:spPr>
              <a:xfrm>
                <a:off x="3747433" y="2422371"/>
                <a:ext cx="511406" cy="35013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kumimoji="1" lang="en-US" altLang="ja-JP" sz="10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Meiryo UI" panose="020B0604030504040204" pitchFamily="50" charset="-128"/>
                    <a:cs typeface="Times New Roman" panose="02020603050405020304" pitchFamily="18" charset="0"/>
                  </a:rPr>
                  <a:t>-</a:t>
                </a:r>
                <a:endParaRPr kumimoji="1" lang="ja-JP" altLang="en-US" sz="10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39" name="グループ化 138"/>
              <p:cNvGrpSpPr/>
              <p:nvPr/>
            </p:nvGrpSpPr>
            <p:grpSpPr>
              <a:xfrm>
                <a:off x="95073" y="2634972"/>
                <a:ext cx="4894981" cy="1583206"/>
                <a:chOff x="95073" y="2489829"/>
                <a:chExt cx="4894981" cy="1583206"/>
              </a:xfrm>
            </p:grpSpPr>
            <p:pic>
              <p:nvPicPr>
                <p:cNvPr id="117" name="図 116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136173" y="2489829"/>
                  <a:ext cx="2333333" cy="1238095"/>
                </a:xfrm>
                <a:prstGeom prst="rect">
                  <a:avLst/>
                </a:prstGeom>
              </p:spPr>
            </p:pic>
            <p:grpSp>
              <p:nvGrpSpPr>
                <p:cNvPr id="138" name="グループ化 137"/>
                <p:cNvGrpSpPr/>
                <p:nvPr/>
              </p:nvGrpSpPr>
              <p:grpSpPr>
                <a:xfrm>
                  <a:off x="95073" y="3576585"/>
                  <a:ext cx="4892140" cy="496450"/>
                  <a:chOff x="95073" y="3576585"/>
                  <a:chExt cx="4892140" cy="496450"/>
                </a:xfrm>
              </p:grpSpPr>
              <p:grpSp>
                <p:nvGrpSpPr>
                  <p:cNvPr id="119" name="グループ化 118"/>
                  <p:cNvGrpSpPr/>
                  <p:nvPr/>
                </p:nvGrpSpPr>
                <p:grpSpPr>
                  <a:xfrm>
                    <a:off x="95073" y="3576585"/>
                    <a:ext cx="1173656" cy="496450"/>
                    <a:chOff x="3916422" y="3492226"/>
                    <a:chExt cx="1173656" cy="496450"/>
                  </a:xfrm>
                </p:grpSpPr>
                <p:sp>
                  <p:nvSpPr>
                    <p:cNvPr id="78" name="正方形/長方形 77"/>
                    <p:cNvSpPr/>
                    <p:nvPr/>
                  </p:nvSpPr>
                  <p:spPr bwMode="auto">
                    <a:xfrm>
                      <a:off x="3916422" y="3492226"/>
                      <a:ext cx="433178" cy="49645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p:txBody>
                </p:sp>
                <p:sp>
                  <p:nvSpPr>
                    <p:cNvPr id="79" name="正方形/長方形 78"/>
                    <p:cNvSpPr/>
                    <p:nvPr/>
                  </p:nvSpPr>
                  <p:spPr bwMode="auto">
                    <a:xfrm>
                      <a:off x="4410074" y="3492226"/>
                      <a:ext cx="433178" cy="49645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80" name="正方形/長方形 79"/>
                    <p:cNvSpPr/>
                    <p:nvPr/>
                  </p:nvSpPr>
                  <p:spPr bwMode="auto">
                    <a:xfrm>
                      <a:off x="4163248" y="3492226"/>
                      <a:ext cx="433178" cy="49645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81" name="正方形/長方形 80"/>
                    <p:cNvSpPr/>
                    <p:nvPr/>
                  </p:nvSpPr>
                  <p:spPr bwMode="auto">
                    <a:xfrm>
                      <a:off x="4656900" y="3492226"/>
                      <a:ext cx="433178" cy="49645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120" name="グループ化 119"/>
                  <p:cNvGrpSpPr/>
                  <p:nvPr/>
                </p:nvGrpSpPr>
                <p:grpSpPr>
                  <a:xfrm>
                    <a:off x="1342197" y="3576585"/>
                    <a:ext cx="1139178" cy="496450"/>
                    <a:chOff x="5163546" y="3451282"/>
                    <a:chExt cx="1139178" cy="496450"/>
                  </a:xfrm>
                </p:grpSpPr>
                <p:sp>
                  <p:nvSpPr>
                    <p:cNvPr id="83" name="正方形/長方形 82"/>
                    <p:cNvSpPr/>
                    <p:nvPr/>
                  </p:nvSpPr>
                  <p:spPr bwMode="auto">
                    <a:xfrm>
                      <a:off x="5163546" y="3451282"/>
                      <a:ext cx="433178" cy="49645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p:txBody>
                </p:sp>
                <p:sp>
                  <p:nvSpPr>
                    <p:cNvPr id="84" name="正方形/長方形 83"/>
                    <p:cNvSpPr/>
                    <p:nvPr/>
                  </p:nvSpPr>
                  <p:spPr bwMode="auto">
                    <a:xfrm>
                      <a:off x="5634212" y="3451282"/>
                      <a:ext cx="433178" cy="49645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85" name="正方形/長方形 84"/>
                    <p:cNvSpPr/>
                    <p:nvPr/>
                  </p:nvSpPr>
                  <p:spPr bwMode="auto">
                    <a:xfrm>
                      <a:off x="5398879" y="3451282"/>
                      <a:ext cx="433178" cy="49645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86" name="正方形/長方形 85"/>
                    <p:cNvSpPr/>
                    <p:nvPr/>
                  </p:nvSpPr>
                  <p:spPr bwMode="auto">
                    <a:xfrm>
                      <a:off x="5869546" y="3451282"/>
                      <a:ext cx="433178" cy="49645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129" name="グループ化 128"/>
                  <p:cNvGrpSpPr/>
                  <p:nvPr/>
                </p:nvGrpSpPr>
                <p:grpSpPr>
                  <a:xfrm>
                    <a:off x="2577367" y="3576585"/>
                    <a:ext cx="1187304" cy="496450"/>
                    <a:chOff x="4013089" y="6494318"/>
                    <a:chExt cx="1187304" cy="496450"/>
                  </a:xfrm>
                </p:grpSpPr>
                <p:sp>
                  <p:nvSpPr>
                    <p:cNvPr id="102" name="正方形/長方形 101"/>
                    <p:cNvSpPr/>
                    <p:nvPr/>
                  </p:nvSpPr>
                  <p:spPr bwMode="auto">
                    <a:xfrm>
                      <a:off x="4013089" y="6494318"/>
                      <a:ext cx="433178" cy="49645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p:txBody>
                </p:sp>
                <p:sp>
                  <p:nvSpPr>
                    <p:cNvPr id="103" name="正方形/長方形 102"/>
                    <p:cNvSpPr/>
                    <p:nvPr/>
                  </p:nvSpPr>
                  <p:spPr bwMode="auto">
                    <a:xfrm>
                      <a:off x="4515839" y="6494318"/>
                      <a:ext cx="433178" cy="49645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04" name="正方形/長方形 103"/>
                    <p:cNvSpPr/>
                    <p:nvPr/>
                  </p:nvSpPr>
                  <p:spPr bwMode="auto">
                    <a:xfrm>
                      <a:off x="4264464" y="6494318"/>
                      <a:ext cx="433178" cy="49645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05" name="正方形/長方形 104"/>
                    <p:cNvSpPr/>
                    <p:nvPr/>
                  </p:nvSpPr>
                  <p:spPr bwMode="auto">
                    <a:xfrm>
                      <a:off x="4767215" y="6494318"/>
                      <a:ext cx="433178" cy="49645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130" name="グループ化 129"/>
                  <p:cNvGrpSpPr/>
                  <p:nvPr/>
                </p:nvGrpSpPr>
                <p:grpSpPr>
                  <a:xfrm>
                    <a:off x="3779795" y="3576585"/>
                    <a:ext cx="1207418" cy="496450"/>
                    <a:chOff x="5215517" y="6553740"/>
                    <a:chExt cx="1207418" cy="496450"/>
                  </a:xfrm>
                </p:grpSpPr>
                <p:sp>
                  <p:nvSpPr>
                    <p:cNvPr id="107" name="正方形/長方形 106"/>
                    <p:cNvSpPr/>
                    <p:nvPr/>
                  </p:nvSpPr>
                  <p:spPr bwMode="auto">
                    <a:xfrm>
                      <a:off x="5215517" y="6553740"/>
                      <a:ext cx="433178" cy="49645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p:txBody>
                </p:sp>
                <p:sp>
                  <p:nvSpPr>
                    <p:cNvPr id="108" name="正方形/長方形 107"/>
                    <p:cNvSpPr/>
                    <p:nvPr/>
                  </p:nvSpPr>
                  <p:spPr bwMode="auto">
                    <a:xfrm>
                      <a:off x="5731677" y="6553740"/>
                      <a:ext cx="433178" cy="49645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09" name="正方形/長方形 108"/>
                    <p:cNvSpPr/>
                    <p:nvPr/>
                  </p:nvSpPr>
                  <p:spPr bwMode="auto">
                    <a:xfrm>
                      <a:off x="5473597" y="6553740"/>
                      <a:ext cx="433178" cy="49645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10" name="正方形/長方形 109"/>
                    <p:cNvSpPr/>
                    <p:nvPr/>
                  </p:nvSpPr>
                  <p:spPr bwMode="auto">
                    <a:xfrm>
                      <a:off x="5989757" y="6553740"/>
                      <a:ext cx="433178" cy="49645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</p:grpSp>
            <p:pic>
              <p:nvPicPr>
                <p:cNvPr id="118" name="図 117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2675768" y="2489829"/>
                  <a:ext cx="2314286" cy="1238095"/>
                </a:xfrm>
                <a:prstGeom prst="rect">
                  <a:avLst/>
                </a:prstGeom>
              </p:spPr>
            </p:pic>
          </p:grpSp>
          <p:cxnSp>
            <p:nvCxnSpPr>
              <p:cNvPr id="134" name="直線コネクタ 133"/>
              <p:cNvCxnSpPr/>
              <p:nvPr/>
            </p:nvCxnSpPr>
            <p:spPr>
              <a:xfrm>
                <a:off x="3871823" y="2350086"/>
                <a:ext cx="1000424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4" name="正方形/長方形 143"/>
            <p:cNvSpPr/>
            <p:nvPr/>
          </p:nvSpPr>
          <p:spPr>
            <a:xfrm>
              <a:off x="2471973" y="1034625"/>
              <a:ext cx="759449" cy="63820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endParaRPr lang="ja-JP" alt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45" name="正方形/長方形 144"/>
          <p:cNvSpPr/>
          <p:nvPr/>
        </p:nvSpPr>
        <p:spPr>
          <a:xfrm>
            <a:off x="-65928" y="4147685"/>
            <a:ext cx="759449" cy="63820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ja-JP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ja-JP" altLang="en-US" sz="1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正方形/長方形 145"/>
          <p:cNvSpPr/>
          <p:nvPr/>
        </p:nvSpPr>
        <p:spPr>
          <a:xfrm>
            <a:off x="2826817" y="4147685"/>
            <a:ext cx="759449" cy="63820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ja-JP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ja-JP" altLang="en-US" sz="1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6" name="グループ化 65"/>
          <p:cNvGrpSpPr/>
          <p:nvPr/>
        </p:nvGrpSpPr>
        <p:grpSpPr>
          <a:xfrm>
            <a:off x="5051453" y="2873163"/>
            <a:ext cx="1220529" cy="999441"/>
            <a:chOff x="5051453" y="2141646"/>
            <a:chExt cx="1220529" cy="999441"/>
          </a:xfrm>
        </p:grpSpPr>
        <p:sp>
          <p:nvSpPr>
            <p:cNvPr id="72" name="Rectangle 22"/>
            <p:cNvSpPr>
              <a:spLocks noChangeArrowheads="1"/>
            </p:cNvSpPr>
            <p:nvPr/>
          </p:nvSpPr>
          <p:spPr bwMode="auto">
            <a:xfrm>
              <a:off x="5181218" y="2520797"/>
              <a:ext cx="1090764" cy="2026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00" dirty="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rPr>
                <a:t>Product</a:t>
              </a:r>
              <a:endParaRPr lang="ja-JP" altLang="en-US" sz="10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3" name="Rectangle 22"/>
            <p:cNvSpPr>
              <a:spLocks noChangeArrowheads="1"/>
            </p:cNvSpPr>
            <p:nvPr/>
          </p:nvSpPr>
          <p:spPr bwMode="auto">
            <a:xfrm>
              <a:off x="5181218" y="2141646"/>
              <a:ext cx="1090764" cy="2026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00" dirty="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rPr>
                <a:t>Substrate</a:t>
              </a:r>
              <a:endParaRPr lang="ja-JP" altLang="en-US" sz="10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4" name="Line 23"/>
            <p:cNvSpPr>
              <a:spLocks noChangeShapeType="1"/>
            </p:cNvSpPr>
            <p:nvPr/>
          </p:nvSpPr>
          <p:spPr bwMode="auto">
            <a:xfrm flipH="1">
              <a:off x="5051453" y="2264260"/>
              <a:ext cx="197184" cy="0"/>
            </a:xfrm>
            <a:prstGeom prst="line">
              <a:avLst/>
            </a:prstGeom>
            <a:noFill/>
            <a:ln w="31750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Line 19"/>
            <p:cNvSpPr>
              <a:spLocks noChangeShapeType="1"/>
            </p:cNvSpPr>
            <p:nvPr/>
          </p:nvSpPr>
          <p:spPr bwMode="auto">
            <a:xfrm>
              <a:off x="5072795" y="2340630"/>
              <a:ext cx="116743" cy="0"/>
            </a:xfrm>
            <a:prstGeom prst="line">
              <a:avLst/>
            </a:prstGeom>
            <a:noFill/>
            <a:ln w="317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Line 21"/>
            <p:cNvSpPr>
              <a:spLocks noChangeShapeType="1"/>
            </p:cNvSpPr>
            <p:nvPr/>
          </p:nvSpPr>
          <p:spPr bwMode="auto">
            <a:xfrm>
              <a:off x="5189538" y="2323212"/>
              <a:ext cx="0" cy="615258"/>
            </a:xfrm>
            <a:prstGeom prst="line">
              <a:avLst/>
            </a:prstGeom>
            <a:noFill/>
            <a:ln w="317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Line 19"/>
            <p:cNvSpPr>
              <a:spLocks noChangeShapeType="1"/>
            </p:cNvSpPr>
            <p:nvPr/>
          </p:nvSpPr>
          <p:spPr bwMode="auto">
            <a:xfrm>
              <a:off x="5072795" y="2917360"/>
              <a:ext cx="116743" cy="0"/>
            </a:xfrm>
            <a:prstGeom prst="line">
              <a:avLst/>
            </a:prstGeom>
            <a:noFill/>
            <a:ln w="317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Rectangle 22"/>
            <p:cNvSpPr>
              <a:spLocks noChangeArrowheads="1"/>
            </p:cNvSpPr>
            <p:nvPr/>
          </p:nvSpPr>
          <p:spPr bwMode="auto">
            <a:xfrm>
              <a:off x="5181218" y="2938470"/>
              <a:ext cx="1090764" cy="2026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00" dirty="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rPr>
                <a:t>Free DNA</a:t>
              </a:r>
              <a:endParaRPr lang="ja-JP" altLang="en-US" sz="10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1" name="Line 23"/>
            <p:cNvSpPr>
              <a:spLocks noChangeShapeType="1"/>
            </p:cNvSpPr>
            <p:nvPr/>
          </p:nvSpPr>
          <p:spPr bwMode="auto">
            <a:xfrm flipH="1">
              <a:off x="5051453" y="3052375"/>
              <a:ext cx="197184" cy="0"/>
            </a:xfrm>
            <a:prstGeom prst="line">
              <a:avLst/>
            </a:prstGeom>
            <a:noFill/>
            <a:ln w="31750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013431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274</TotalTime>
  <Words>55</Words>
  <Application>Microsoft Office PowerPoint</Application>
  <PresentationFormat>ユーザー設定</PresentationFormat>
  <Paragraphs>3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Meiryo UI</vt:lpstr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研究報告 2016/02/19</dc:title>
  <dc:creator>船越昌史</dc:creator>
  <cp:lastModifiedBy>Masafumi Funakoshi</cp:lastModifiedBy>
  <cp:revision>523</cp:revision>
  <cp:lastPrinted>2017-02-13T10:50:11Z</cp:lastPrinted>
  <dcterms:created xsi:type="dcterms:W3CDTF">2017-02-09T05:19:39Z</dcterms:created>
  <dcterms:modified xsi:type="dcterms:W3CDTF">2017-09-20T11:07:22Z</dcterms:modified>
</cp:coreProperties>
</file>